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0" r:id="rId2"/>
  </p:sldIdLst>
  <p:sldSz cx="12192000" cy="6858000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73464" autoAdjust="0"/>
  </p:normalViewPr>
  <p:slideViewPr>
    <p:cSldViewPr snapToGrid="0">
      <p:cViewPr varScale="1">
        <p:scale>
          <a:sx n="114" d="100"/>
          <a:sy n="114" d="100"/>
        </p:scale>
        <p:origin x="300" y="102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Grid="0">
      <p:cViewPr>
        <p:scale>
          <a:sx n="80" d="100"/>
          <a:sy n="80" d="100"/>
        </p:scale>
        <p:origin x="3150" y="30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13763" cy="467071"/>
          </a:xfrm>
          <a:prstGeom prst="rect">
            <a:avLst/>
          </a:prstGeom>
        </p:spPr>
        <p:txBody>
          <a:bodyPr vert="horz" lIns="93795" tIns="46898" rIns="93795" bIns="4689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39466" y="1"/>
            <a:ext cx="3013763" cy="467071"/>
          </a:xfrm>
          <a:prstGeom prst="rect">
            <a:avLst/>
          </a:prstGeom>
        </p:spPr>
        <p:txBody>
          <a:bodyPr vert="horz" lIns="93795" tIns="46898" rIns="93795" bIns="46898" rtlCol="0"/>
          <a:lstStyle>
            <a:lvl1pPr algn="r">
              <a:defRPr sz="1200"/>
            </a:lvl1pPr>
          </a:lstStyle>
          <a:p>
            <a:fld id="{B6989978-BB30-4DB7-BC6C-DF90AE099445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42031"/>
            <a:ext cx="3013763" cy="467070"/>
          </a:xfrm>
          <a:prstGeom prst="rect">
            <a:avLst/>
          </a:prstGeom>
        </p:spPr>
        <p:txBody>
          <a:bodyPr vert="horz" lIns="93795" tIns="46898" rIns="93795" bIns="4689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39466" y="8842031"/>
            <a:ext cx="3013763" cy="467070"/>
          </a:xfrm>
          <a:prstGeom prst="rect">
            <a:avLst/>
          </a:prstGeom>
        </p:spPr>
        <p:txBody>
          <a:bodyPr vert="horz" lIns="93795" tIns="46898" rIns="93795" bIns="46898" rtlCol="0" anchor="b"/>
          <a:lstStyle>
            <a:lvl1pPr algn="r">
              <a:defRPr sz="1200"/>
            </a:lvl1pPr>
          </a:lstStyle>
          <a:p>
            <a:fld id="{5AE4A195-4617-4223-BFFB-C2958B5B827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69442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13763" cy="467071"/>
          </a:xfrm>
          <a:prstGeom prst="rect">
            <a:avLst/>
          </a:prstGeom>
        </p:spPr>
        <p:txBody>
          <a:bodyPr vert="horz" lIns="93795" tIns="46898" rIns="93795" bIns="4689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1"/>
            <a:ext cx="3013763" cy="467071"/>
          </a:xfrm>
          <a:prstGeom prst="rect">
            <a:avLst/>
          </a:prstGeom>
        </p:spPr>
        <p:txBody>
          <a:bodyPr vert="horz" lIns="93795" tIns="46898" rIns="93795" bIns="46898" rtlCol="0"/>
          <a:lstStyle>
            <a:lvl1pPr algn="r">
              <a:defRPr sz="1200"/>
            </a:lvl1pPr>
          </a:lstStyle>
          <a:p>
            <a:fld id="{25D89876-D5E7-4986-AF04-4BC65FE8E7B2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2625" y="1163638"/>
            <a:ext cx="5589588" cy="3143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795" tIns="46898" rIns="93795" bIns="4689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80005"/>
            <a:ext cx="5563870" cy="3665459"/>
          </a:xfrm>
          <a:prstGeom prst="rect">
            <a:avLst/>
          </a:prstGeom>
        </p:spPr>
        <p:txBody>
          <a:bodyPr vert="horz" lIns="93795" tIns="46898" rIns="93795" bIns="4689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42031"/>
            <a:ext cx="3013763" cy="467070"/>
          </a:xfrm>
          <a:prstGeom prst="rect">
            <a:avLst/>
          </a:prstGeom>
        </p:spPr>
        <p:txBody>
          <a:bodyPr vert="horz" lIns="93795" tIns="46898" rIns="93795" bIns="4689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842031"/>
            <a:ext cx="3013763" cy="467070"/>
          </a:xfrm>
          <a:prstGeom prst="rect">
            <a:avLst/>
          </a:prstGeom>
        </p:spPr>
        <p:txBody>
          <a:bodyPr vert="horz" lIns="93795" tIns="46898" rIns="93795" bIns="46898" rtlCol="0" anchor="b"/>
          <a:lstStyle>
            <a:lvl1pPr algn="r">
              <a:defRPr sz="1200"/>
            </a:lvl1pPr>
          </a:lstStyle>
          <a:p>
            <a:fld id="{725D58BE-2E87-42B7-BF88-36DC32C8A46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4002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7694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7653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2747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3091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690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6077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994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4172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6820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2478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7427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BCAD7-32BC-4849-AB58-13A52A63962E}" type="datetimeFigureOut">
              <a:rPr lang="en-US" smtClean="0"/>
              <a:t>8/1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39329-E0D3-4644-8D99-4710E3018D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3220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image" Target="../media/image2.emf"/><Relationship Id="rId5" Type="http://schemas.openxmlformats.org/officeDocument/2006/relationships/oleObject" Target="../embeddings/oleObject1.bin"/><Relationship Id="rId10" Type="http://schemas.openxmlformats.org/officeDocument/2006/relationships/oleObject" Target="../embeddings/oleObject2.bin"/><Relationship Id="rId4" Type="http://schemas.microsoft.com/office/2007/relationships/hdphoto" Target="../media/hdphoto1.wdp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090A2A4F-8E29-46C9-9A57-FCF098AF65E9}"/>
              </a:ext>
            </a:extLst>
          </p:cNvPr>
          <p:cNvSpPr/>
          <p:nvPr/>
        </p:nvSpPr>
        <p:spPr>
          <a:xfrm>
            <a:off x="795130" y="94869"/>
            <a:ext cx="110063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S1. </a:t>
            </a:r>
            <a:r>
              <a:rPr lang="en-US" dirty="0"/>
              <a:t>Knockout of</a:t>
            </a:r>
            <a:r>
              <a:rPr lang="en-US" i="1" dirty="0"/>
              <a:t> </a:t>
            </a:r>
            <a:r>
              <a:rPr lang="en-US" altLang="zh-CN" dirty="0"/>
              <a:t>new</a:t>
            </a:r>
            <a:r>
              <a:rPr lang="en-US" altLang="zh-CN" i="1" dirty="0"/>
              <a:t> </a:t>
            </a:r>
            <a:r>
              <a:rPr lang="en-US" i="1" dirty="0"/>
              <a:t>JAK3-INSL3 </a:t>
            </a:r>
            <a:r>
              <a:rPr lang="en-US" dirty="0"/>
              <a:t>fusion transcript inhibited cell proliferation and colony-formation in MJ cells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45346DF3-4277-457F-B79B-26B14292C4FB}"/>
              </a:ext>
            </a:extLst>
          </p:cNvPr>
          <p:cNvGrpSpPr/>
          <p:nvPr/>
        </p:nvGrpSpPr>
        <p:grpSpPr>
          <a:xfrm>
            <a:off x="1014496" y="440348"/>
            <a:ext cx="10543577" cy="5300829"/>
            <a:chOff x="966788" y="1062684"/>
            <a:chExt cx="10543577" cy="530082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C93E3E8-7B53-4644-9A38-FE07189D80B7}"/>
                </a:ext>
              </a:extLst>
            </p:cNvPr>
            <p:cNvGrpSpPr/>
            <p:nvPr/>
          </p:nvGrpSpPr>
          <p:grpSpPr>
            <a:xfrm>
              <a:off x="5056236" y="2248756"/>
              <a:ext cx="3546617" cy="2915084"/>
              <a:chOff x="4322691" y="1152091"/>
              <a:chExt cx="3546617" cy="2915084"/>
            </a:xfrm>
          </p:grpSpPr>
          <p:pic>
            <p:nvPicPr>
              <p:cNvPr id="6" name="Picture 5" descr="A plastic container with purple circles&#10;&#10;Description automatically generated">
                <a:extLst>
                  <a:ext uri="{FF2B5EF4-FFF2-40B4-BE49-F238E27FC236}">
                    <a16:creationId xmlns:a16="http://schemas.microsoft.com/office/drawing/2014/main" id="{507B6DDB-E5AE-4875-A404-2ED550EB1A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53" t="67893" r="40679" b="3216"/>
              <a:stretch/>
            </p:blipFill>
            <p:spPr>
              <a:xfrm flipH="1">
                <a:off x="4322691" y="1485729"/>
                <a:ext cx="3546617" cy="2581446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B8EB3AA-B34E-416E-B4EF-54B12931835C}"/>
                  </a:ext>
                </a:extLst>
              </p:cNvPr>
              <p:cNvSpPr txBox="1"/>
              <p:nvPr/>
            </p:nvSpPr>
            <p:spPr>
              <a:xfrm>
                <a:off x="4457700" y="1154497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#Ctrl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35BF47D5-CBB4-40C5-923C-1120208E09F9}"/>
                  </a:ext>
                </a:extLst>
              </p:cNvPr>
              <p:cNvSpPr txBox="1"/>
              <p:nvPr/>
            </p:nvSpPr>
            <p:spPr>
              <a:xfrm>
                <a:off x="5212424" y="1154496"/>
                <a:ext cx="8835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RNA#1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EC74A5C5-EA3A-4BB8-B9E2-4DB63CAD5493}"/>
                  </a:ext>
                </a:extLst>
              </p:cNvPr>
              <p:cNvSpPr txBox="1"/>
              <p:nvPr/>
            </p:nvSpPr>
            <p:spPr>
              <a:xfrm>
                <a:off x="6095998" y="1152091"/>
                <a:ext cx="8835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RNA#2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9F75281-961D-404D-AA14-E82715026157}"/>
                  </a:ext>
                </a:extLst>
              </p:cNvPr>
              <p:cNvSpPr txBox="1"/>
              <p:nvPr/>
            </p:nvSpPr>
            <p:spPr>
              <a:xfrm>
                <a:off x="6879299" y="1152091"/>
                <a:ext cx="8835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RNA#3</a:t>
                </a:r>
              </a:p>
            </p:txBody>
          </p:sp>
        </p:grpSp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839635CD-46D1-47F1-AF88-2931EF721B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10200156"/>
                </p:ext>
              </p:extLst>
            </p:nvPr>
          </p:nvGraphicFramePr>
          <p:xfrm>
            <a:off x="1086624" y="2799576"/>
            <a:ext cx="3273425" cy="3563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4" name="Prism 9" r:id="rId5" imgW="3099328" imgH="3374722" progId="Prism9.Document">
                    <p:embed/>
                  </p:oleObj>
                </mc:Choice>
                <mc:Fallback>
                  <p:oleObj name="Prism 9" r:id="rId5" imgW="3099328" imgH="337472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86624" y="2799576"/>
                          <a:ext cx="3273425" cy="35639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A387B88F-6547-4940-9124-53E5851C7699}"/>
                </a:ext>
              </a:extLst>
            </p:cNvPr>
            <p:cNvGrpSpPr/>
            <p:nvPr/>
          </p:nvGrpSpPr>
          <p:grpSpPr>
            <a:xfrm>
              <a:off x="1531508" y="1062684"/>
              <a:ext cx="3046582" cy="1768232"/>
              <a:chOff x="1491753" y="999076"/>
              <a:chExt cx="3046582" cy="1768232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9996A08A-0CA5-438A-8A48-56B385F75378}"/>
                  </a:ext>
                </a:extLst>
              </p:cNvPr>
              <p:cNvGrpSpPr/>
              <p:nvPr/>
            </p:nvGrpSpPr>
            <p:grpSpPr>
              <a:xfrm>
                <a:off x="1491753" y="1800239"/>
                <a:ext cx="3046582" cy="967069"/>
                <a:chOff x="4846047" y="4411162"/>
                <a:chExt cx="3046582" cy="967069"/>
              </a:xfrm>
            </p:grpSpPr>
            <p:sp>
              <p:nvSpPr>
                <p:cNvPr id="132" name="TextBox 131">
                  <a:extLst>
                    <a:ext uri="{FF2B5EF4-FFF2-40B4-BE49-F238E27FC236}">
                      <a16:creationId xmlns:a16="http://schemas.microsoft.com/office/drawing/2014/main" id="{178DB3A8-CC36-4B79-B334-076A0D8D6E97}"/>
                    </a:ext>
                  </a:extLst>
                </p:cNvPr>
                <p:cNvSpPr txBox="1"/>
                <p:nvPr/>
              </p:nvSpPr>
              <p:spPr>
                <a:xfrm flipH="1">
                  <a:off x="4846047" y="5029489"/>
                  <a:ext cx="70681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42 kDa</a:t>
                  </a: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59B374CB-F880-491C-AB5F-F8B38659E04C}"/>
                    </a:ext>
                  </a:extLst>
                </p:cNvPr>
                <p:cNvSpPr txBox="1"/>
                <p:nvPr/>
              </p:nvSpPr>
              <p:spPr>
                <a:xfrm flipH="1">
                  <a:off x="4846047" y="4544200"/>
                  <a:ext cx="70681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15 kDa</a:t>
                  </a:r>
                </a:p>
              </p:txBody>
            </p:sp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4589C768-6F58-487D-9D6C-9E1EE1AD5FBC}"/>
                    </a:ext>
                  </a:extLst>
                </p:cNvPr>
                <p:cNvGrpSpPr/>
                <p:nvPr/>
              </p:nvGrpSpPr>
              <p:grpSpPr>
                <a:xfrm>
                  <a:off x="5478357" y="4411162"/>
                  <a:ext cx="2414272" cy="967069"/>
                  <a:chOff x="5478357" y="4411162"/>
                  <a:chExt cx="2414272" cy="967069"/>
                </a:xfrm>
              </p:grpSpPr>
              <p:pic>
                <p:nvPicPr>
                  <p:cNvPr id="15" name="Picture 14" descr="A black and white photo of a rectangular object&#10;&#10;Description automatically generated">
                    <a:extLst>
                      <a:ext uri="{FF2B5EF4-FFF2-40B4-BE49-F238E27FC236}">
                        <a16:creationId xmlns:a16="http://schemas.microsoft.com/office/drawing/2014/main" id="{22043879-552C-4AAF-9680-EFD38A75A9E4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7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532" t="30519" r="52401" b="60948"/>
                  <a:stretch/>
                </p:blipFill>
                <p:spPr>
                  <a:xfrm>
                    <a:off x="5594869" y="4411162"/>
                    <a:ext cx="1371600" cy="457200"/>
                  </a:xfrm>
                  <a:prstGeom prst="rect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</p:pic>
              <p:pic>
                <p:nvPicPr>
                  <p:cNvPr id="17" name="Picture 16" descr="A black and white image of a bar&#10;&#10;Description automatically generated">
                    <a:extLst>
                      <a:ext uri="{FF2B5EF4-FFF2-40B4-BE49-F238E27FC236}">
                        <a16:creationId xmlns:a16="http://schemas.microsoft.com/office/drawing/2014/main" id="{4024CE99-C55A-4E42-82D8-C3F9670696FE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734" t="38891" r="50952" b="50000"/>
                  <a:stretch/>
                </p:blipFill>
                <p:spPr>
                  <a:xfrm>
                    <a:off x="5594869" y="4921031"/>
                    <a:ext cx="1371600" cy="457200"/>
                  </a:xfrm>
                  <a:prstGeom prst="rect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</p:pic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D620B749-E6CE-4C2B-8786-81300590D5C9}"/>
                      </a:ext>
                    </a:extLst>
                  </p:cNvPr>
                  <p:cNvGrpSpPr/>
                  <p:nvPr/>
                </p:nvGrpSpPr>
                <p:grpSpPr>
                  <a:xfrm>
                    <a:off x="7004675" y="4552151"/>
                    <a:ext cx="647566" cy="261610"/>
                    <a:chOff x="6985625" y="4552151"/>
                    <a:chExt cx="647566" cy="261610"/>
                  </a:xfrm>
                </p:grpSpPr>
                <p:sp>
                  <p:nvSpPr>
                    <p:cNvPr id="116" name="TextBox 115">
                      <a:extLst>
                        <a:ext uri="{FF2B5EF4-FFF2-40B4-BE49-F238E27FC236}">
                          <a16:creationId xmlns:a16="http://schemas.microsoft.com/office/drawing/2014/main" id="{9C3500CD-CD03-442C-B0E5-7AC547EADB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47774" y="4552151"/>
                      <a:ext cx="58541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L3</a:t>
                      </a:r>
                    </a:p>
                  </p:txBody>
                </p:sp>
                <p:cxnSp>
                  <p:nvCxnSpPr>
                    <p:cNvPr id="120" name="Straight Arrow Connector 119">
                      <a:extLst>
                        <a:ext uri="{FF2B5EF4-FFF2-40B4-BE49-F238E27FC236}">
                          <a16:creationId xmlns:a16="http://schemas.microsoft.com/office/drawing/2014/main" id="{186B9B6E-9B1D-479D-810D-89C9272FA22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985625" y="4680640"/>
                      <a:ext cx="124768" cy="0"/>
                    </a:xfrm>
                    <a:prstGeom prst="straightConnector1">
                      <a:avLst/>
                    </a:prstGeom>
                    <a:ln w="22225">
                      <a:tailEnd type="triangle"/>
                    </a:ln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9" name="Group 18">
                    <a:extLst>
                      <a:ext uri="{FF2B5EF4-FFF2-40B4-BE49-F238E27FC236}">
                        <a16:creationId xmlns:a16="http://schemas.microsoft.com/office/drawing/2014/main" id="{C3890C1B-C10B-4399-9F6A-048DA619188D}"/>
                      </a:ext>
                    </a:extLst>
                  </p:cNvPr>
                  <p:cNvGrpSpPr/>
                  <p:nvPr/>
                </p:nvGrpSpPr>
                <p:grpSpPr>
                  <a:xfrm>
                    <a:off x="7011025" y="5022051"/>
                    <a:ext cx="881604" cy="261610"/>
                    <a:chOff x="6947525" y="5079201"/>
                    <a:chExt cx="881604" cy="261610"/>
                  </a:xfrm>
                </p:grpSpPr>
                <p:sp>
                  <p:nvSpPr>
                    <p:cNvPr id="130" name="TextBox 129">
                      <a:extLst>
                        <a:ext uri="{FF2B5EF4-FFF2-40B4-BE49-F238E27FC236}">
                          <a16:creationId xmlns:a16="http://schemas.microsoft.com/office/drawing/2014/main" id="{AA774E1D-5C3A-409E-A080-6521089CB2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09674" y="5079201"/>
                      <a:ext cx="819455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-actin</a:t>
                      </a:r>
                    </a:p>
                  </p:txBody>
                </p:sp>
                <p:cxnSp>
                  <p:nvCxnSpPr>
                    <p:cNvPr id="131" name="Straight Arrow Connector 130">
                      <a:extLst>
                        <a:ext uri="{FF2B5EF4-FFF2-40B4-BE49-F238E27FC236}">
                          <a16:creationId xmlns:a16="http://schemas.microsoft.com/office/drawing/2014/main" id="{4A872667-E87C-4AD1-BF62-59BA956DADD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947525" y="5207690"/>
                      <a:ext cx="124768" cy="0"/>
                    </a:xfrm>
                    <a:prstGeom prst="straightConnector1">
                      <a:avLst/>
                    </a:prstGeom>
                    <a:ln w="22225">
                      <a:tailEnd type="triangle"/>
                    </a:ln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33" name="Straight Connector 132">
                    <a:extLst>
                      <a:ext uri="{FF2B5EF4-FFF2-40B4-BE49-F238E27FC236}">
                        <a16:creationId xmlns:a16="http://schemas.microsoft.com/office/drawing/2014/main" id="{9351C424-1B3A-4889-A21B-F5FDD431FD49}"/>
                      </a:ext>
                    </a:extLst>
                  </p:cNvPr>
                  <p:cNvCxnSpPr/>
                  <p:nvPr/>
                </p:nvCxnSpPr>
                <p:spPr>
                  <a:xfrm>
                    <a:off x="5478357" y="5160551"/>
                    <a:ext cx="91440" cy="0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5" name="Straight Connector 134">
                    <a:extLst>
                      <a:ext uri="{FF2B5EF4-FFF2-40B4-BE49-F238E27FC236}">
                        <a16:creationId xmlns:a16="http://schemas.microsoft.com/office/drawing/2014/main" id="{05CE577B-EE2E-460A-86BC-084778102DCD}"/>
                      </a:ext>
                    </a:extLst>
                  </p:cNvPr>
                  <p:cNvCxnSpPr/>
                  <p:nvPr/>
                </p:nvCxnSpPr>
                <p:spPr>
                  <a:xfrm>
                    <a:off x="5478357" y="4675262"/>
                    <a:ext cx="91440" cy="0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B80F563-93F0-4162-8083-897D1437F974}"/>
                  </a:ext>
                </a:extLst>
              </p:cNvPr>
              <p:cNvGrpSpPr/>
              <p:nvPr/>
            </p:nvGrpSpPr>
            <p:grpSpPr>
              <a:xfrm>
                <a:off x="2413896" y="999076"/>
                <a:ext cx="1341742" cy="886543"/>
                <a:chOff x="2413896" y="999076"/>
                <a:chExt cx="1341742" cy="886543"/>
              </a:xfrm>
            </p:grpSpPr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5FB2AB68-7528-4C0C-8902-545AB761CC51}"/>
                    </a:ext>
                  </a:extLst>
                </p:cNvPr>
                <p:cNvSpPr txBox="1"/>
                <p:nvPr/>
              </p:nvSpPr>
              <p:spPr>
                <a:xfrm rot="18445634">
                  <a:off x="2186751" y="1357846"/>
                  <a:ext cx="73129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#Ctrl</a:t>
                  </a:r>
                </a:p>
              </p:txBody>
            </p:sp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8923CAF1-F20E-43BD-A0A2-2B4754DCCA2C}"/>
                    </a:ext>
                  </a:extLst>
                </p:cNvPr>
                <p:cNvSpPr txBox="1"/>
                <p:nvPr/>
              </p:nvSpPr>
              <p:spPr>
                <a:xfrm rot="18445634">
                  <a:off x="2489092" y="1305331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1</a:t>
                  </a:r>
                </a:p>
              </p:txBody>
            </p: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DA372884-24AA-4853-9E18-9D86D96F08A3}"/>
                    </a:ext>
                  </a:extLst>
                </p:cNvPr>
                <p:cNvSpPr txBox="1"/>
                <p:nvPr/>
              </p:nvSpPr>
              <p:spPr>
                <a:xfrm rot="18445634">
                  <a:off x="2846969" y="1302364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2</a:t>
                  </a:r>
                </a:p>
              </p:txBody>
            </p:sp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23CBEA6C-CB66-4FCF-96F1-3F34BFC24F93}"/>
                    </a:ext>
                  </a:extLst>
                </p:cNvPr>
                <p:cNvSpPr txBox="1"/>
                <p:nvPr/>
              </p:nvSpPr>
              <p:spPr>
                <a:xfrm rot="18445634">
                  <a:off x="3175351" y="1305332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3</a:t>
                  </a:r>
                </a:p>
              </p:txBody>
            </p:sp>
          </p:grp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BDC76C4B-EEA1-46CE-8BB6-C8AA18616168}"/>
                </a:ext>
              </a:extLst>
            </p:cNvPr>
            <p:cNvGrpSpPr/>
            <p:nvPr/>
          </p:nvGrpSpPr>
          <p:grpSpPr>
            <a:xfrm>
              <a:off x="8853481" y="2257439"/>
              <a:ext cx="2656884" cy="2967442"/>
              <a:chOff x="8853481" y="2257439"/>
              <a:chExt cx="2656884" cy="2967442"/>
            </a:xfrm>
          </p:grpSpPr>
          <p:graphicFrame>
            <p:nvGraphicFramePr>
              <p:cNvPr id="9" name="Object 8">
                <a:extLst>
                  <a:ext uri="{FF2B5EF4-FFF2-40B4-BE49-F238E27FC236}">
                    <a16:creationId xmlns:a16="http://schemas.microsoft.com/office/drawing/2014/main" id="{905665AE-D548-4765-82E7-82462FEB557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5087935"/>
                  </p:ext>
                </p:extLst>
              </p:nvPr>
            </p:nvGraphicFramePr>
            <p:xfrm>
              <a:off x="8853481" y="2257439"/>
              <a:ext cx="2656884" cy="24738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195" name="Prism 9" r:id="rId10" imgW="2381217" imgH="2377751" progId="Prism9.Document">
                      <p:embed/>
                    </p:oleObj>
                  </mc:Choice>
                  <mc:Fallback>
                    <p:oleObj name="Prism 9" r:id="rId10" imgW="2381217" imgH="2377751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853481" y="2257439"/>
                            <a:ext cx="2656884" cy="24738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22247C83-EBA9-408A-84C5-23F68401C36D}"/>
                  </a:ext>
                </a:extLst>
              </p:cNvPr>
              <p:cNvGrpSpPr/>
              <p:nvPr/>
            </p:nvGrpSpPr>
            <p:grpSpPr>
              <a:xfrm>
                <a:off x="9558758" y="4332161"/>
                <a:ext cx="1245137" cy="892720"/>
                <a:chOff x="2461602" y="954337"/>
                <a:chExt cx="1245137" cy="892720"/>
              </a:xfrm>
            </p:grpSpPr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DFF9157C-3A85-4AF3-9928-B3C8849B7412}"/>
                    </a:ext>
                  </a:extLst>
                </p:cNvPr>
                <p:cNvSpPr txBox="1"/>
                <p:nvPr/>
              </p:nvSpPr>
              <p:spPr>
                <a:xfrm rot="18445634">
                  <a:off x="2234457" y="1198819"/>
                  <a:ext cx="73129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#Ctrl</a:t>
                  </a:r>
                </a:p>
              </p:txBody>
            </p:sp>
            <p:sp>
              <p:nvSpPr>
                <p:cNvPr id="143" name="TextBox 142">
                  <a:extLst>
                    <a:ext uri="{FF2B5EF4-FFF2-40B4-BE49-F238E27FC236}">
                      <a16:creationId xmlns:a16="http://schemas.microsoft.com/office/drawing/2014/main" id="{53861DBD-5B80-4527-BEFD-C38F7B457996}"/>
                    </a:ext>
                  </a:extLst>
                </p:cNvPr>
                <p:cNvSpPr txBox="1"/>
                <p:nvPr/>
              </p:nvSpPr>
              <p:spPr>
                <a:xfrm rot="18445634">
                  <a:off x="2489092" y="1257625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1</a:t>
                  </a:r>
                </a:p>
              </p:txBody>
            </p:sp>
            <p:sp>
              <p:nvSpPr>
                <p:cNvPr id="155" name="TextBox 154">
                  <a:extLst>
                    <a:ext uri="{FF2B5EF4-FFF2-40B4-BE49-F238E27FC236}">
                      <a16:creationId xmlns:a16="http://schemas.microsoft.com/office/drawing/2014/main" id="{60185730-F88A-4F6F-875B-803AF8AACA72}"/>
                    </a:ext>
                  </a:extLst>
                </p:cNvPr>
                <p:cNvSpPr txBox="1"/>
                <p:nvPr/>
              </p:nvSpPr>
              <p:spPr>
                <a:xfrm rot="18445634">
                  <a:off x="2791312" y="1262609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2</a:t>
                  </a:r>
                </a:p>
              </p:txBody>
            </p:sp>
            <p:sp>
              <p:nvSpPr>
                <p:cNvPr id="156" name="TextBox 155">
                  <a:extLst>
                    <a:ext uri="{FF2B5EF4-FFF2-40B4-BE49-F238E27FC236}">
                      <a16:creationId xmlns:a16="http://schemas.microsoft.com/office/drawing/2014/main" id="{29EEE12B-1FB8-4617-8435-F36A80B655C1}"/>
                    </a:ext>
                  </a:extLst>
                </p:cNvPr>
                <p:cNvSpPr txBox="1"/>
                <p:nvPr/>
              </p:nvSpPr>
              <p:spPr>
                <a:xfrm rot="18445634">
                  <a:off x="3126452" y="1266770"/>
                  <a:ext cx="8835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gRNA#3</a:t>
                  </a:r>
                </a:p>
              </p:txBody>
            </p:sp>
          </p:grp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3295CA9-35B9-483A-AAFA-93634918D432}"/>
                </a:ext>
              </a:extLst>
            </p:cNvPr>
            <p:cNvSpPr txBox="1"/>
            <p:nvPr/>
          </p:nvSpPr>
          <p:spPr>
            <a:xfrm>
              <a:off x="966788" y="1151163"/>
              <a:ext cx="298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4B2F8764-A916-405C-87CA-D3FD81040E91}"/>
                </a:ext>
              </a:extLst>
            </p:cNvPr>
            <p:cNvSpPr txBox="1"/>
            <p:nvPr/>
          </p:nvSpPr>
          <p:spPr>
            <a:xfrm>
              <a:off x="966788" y="2653331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957475E4-9917-4AE3-8511-076097E95664}"/>
                </a:ext>
              </a:extLst>
            </p:cNvPr>
            <p:cNvSpPr txBox="1"/>
            <p:nvPr/>
          </p:nvSpPr>
          <p:spPr>
            <a:xfrm>
              <a:off x="4888434" y="1914622"/>
              <a:ext cx="2808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19B7CC2D-DBBA-46D6-81EC-E453D9C8D2B7}"/>
                </a:ext>
              </a:extLst>
            </p:cNvPr>
            <p:cNvSpPr txBox="1"/>
            <p:nvPr/>
          </p:nvSpPr>
          <p:spPr>
            <a:xfrm>
              <a:off x="8704241" y="1969223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id="{AB592AB1-A792-4136-A045-AFE3B0537E3A}"/>
              </a:ext>
            </a:extLst>
          </p:cNvPr>
          <p:cNvSpPr txBox="1"/>
          <p:nvPr/>
        </p:nvSpPr>
        <p:spPr>
          <a:xfrm>
            <a:off x="740222" y="5810748"/>
            <a:ext cx="1111616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nockout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Jak3-INSL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hibited cell proliferation and colony-formation in MJ cells. (a) The efficiency of INSL3 knockout in different INSL3-sgRNA (sgRNA#1, sgRNA#2, sgRNA#3) and corresponding control sgRNA (non-target sg#Ctrl) cells by western blot analysis;  (b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Titer-GloT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Luminescent Cell Viability Assay was used to assess cell viability at 24 hours and 48 hours for CRISPR/Cas-9 knockout (sgRNA#1, sgRNA#2, sgRNA#3 or non-target sg#Ctrl) MJ cells. The cell viability was reduced in knockout MJ cells comparison with control sgRNA cells; (c) Soft agar colony formation assay was performed using INSL3 knockout (sgRNA#1, sgRNA#2, sgRNA#3) or  control MJ cells (non-target sg#Ctrl); (d) Quantitative analysis of colony formation in INSL3 knock out and control MJ cells; Results represent the mean ± SD: 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5; *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1.</a:t>
            </a:r>
          </a:p>
        </p:txBody>
      </p:sp>
    </p:spTree>
    <p:extLst>
      <p:ext uri="{BB962C8B-B14F-4D97-AF65-F5344CB8AC3E}">
        <p14:creationId xmlns:p14="http://schemas.microsoft.com/office/powerpoint/2010/main" val="3049349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94</TotalTime>
  <Words>251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ncogenic JAK3 mRNA isoform in cutaneous T-cell lymphoma</dc:title>
  <dc:creator>Ni,Xiao</dc:creator>
  <cp:lastModifiedBy>Ni,Xiao</cp:lastModifiedBy>
  <cp:revision>295</cp:revision>
  <cp:lastPrinted>2023-06-02T21:31:03Z</cp:lastPrinted>
  <dcterms:created xsi:type="dcterms:W3CDTF">2021-01-05T20:29:16Z</dcterms:created>
  <dcterms:modified xsi:type="dcterms:W3CDTF">2023-08-10T21:36:37Z</dcterms:modified>
</cp:coreProperties>
</file>